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97" r:id="rId2"/>
  </p:sldIdLst>
  <p:sldSz cx="755967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6C0A"/>
    <a:srgbClr val="77933C"/>
    <a:srgbClr val="F070B3"/>
    <a:srgbClr val="A9D18E"/>
    <a:srgbClr val="F23EDD"/>
    <a:srgbClr val="01B601"/>
    <a:srgbClr val="FF6200"/>
    <a:srgbClr val="FFD8BE"/>
    <a:srgbClr val="00B72E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165" autoAdjust="0"/>
    <p:restoredTop sz="95220" autoAdjust="0"/>
  </p:normalViewPr>
  <p:slideViewPr>
    <p:cSldViewPr snapToGrid="0">
      <p:cViewPr varScale="1">
        <p:scale>
          <a:sx n="54" d="100"/>
          <a:sy n="54" d="100"/>
        </p:scale>
        <p:origin x="271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1-&#24037;&#20316;1\2-&#22312;&#30740;&#39033;&#30446;\2-NO%20and%20Gdpd2\66-Figure\Figure&#29992;&#22270;\Figure5\WT&#19982;Gdpd2_KO_Club&#20811;&#38534;D8&#32479;&#3574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3731;&#38738;\Desktop\Gdpd2\&#23454;&#39564;&#25968;&#25454;\20220621-NO&#21050;&#28608;Gdpd2-KO-Club&#27597;&#40736;\&#32479;&#35745;\&#26032;&#24314;%20Microsoft%20Excel%20&#24037;&#20316;&#34920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Gdpd2\&#23454;&#39564;&#25968;&#25454;\20220621-NO&#21050;&#28608;Gdpd2-KO-Club&#27597;&#40736;\&#32479;&#35745;\&#26032;&#24314;%20Microsoft%20Excel%20&#24037;&#20316;&#3492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Gdpd2\&#23454;&#39564;&#25968;&#25454;\20220611-25&#956;M%20DEA%20NONOate&#19982;Gdpd2-KO-Club&#20849;&#22521;&#20859;&#65288;&#37325;&#22797;&#65289;\20220611-NO&#19982;Gdpd2-KO-Club&#20849;&#22521;&#20859;D8&#32479;&#35745;%20(2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465370370370369"/>
          <c:y val="0.12923793100896247"/>
          <c:w val="0.58599444444444448"/>
          <c:h val="0.69452852670608867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rgbClr val="E46C0A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0CC-49B8-9005-4E145E709C5B}"/>
              </c:ext>
            </c:extLst>
          </c:dPt>
          <c:errBars>
            <c:errBarType val="plus"/>
            <c:errValType val="cust"/>
            <c:noEndCap val="0"/>
            <c:plus>
              <c:numRef>
                <c:f>统计!$I$14:$I$15</c:f>
                <c:numCache>
                  <c:formatCode>General</c:formatCode>
                  <c:ptCount val="2"/>
                  <c:pt idx="0">
                    <c:v>1.829047667227736</c:v>
                  </c:pt>
                  <c:pt idx="1">
                    <c:v>11.1315433241862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统计!$G$14:$G$15</c:f>
              <c:strCache>
                <c:ptCount val="2"/>
                <c:pt idx="0">
                  <c:v>CTL</c:v>
                </c:pt>
                <c:pt idx="1">
                  <c:v>Gdpd2 KO</c:v>
                </c:pt>
              </c:strCache>
            </c:strRef>
          </c:cat>
          <c:val>
            <c:numRef>
              <c:f>统计!$H$14:$H$15</c:f>
              <c:numCache>
                <c:formatCode>General</c:formatCode>
                <c:ptCount val="2"/>
                <c:pt idx="0">
                  <c:v>196.08279065168523</c:v>
                </c:pt>
                <c:pt idx="1">
                  <c:v>174.645137869399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CC-49B8-9005-4E145E709C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736931616"/>
        <c:axId val="1736934944"/>
      </c:barChart>
      <c:catAx>
        <c:axId val="1736931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736934944"/>
        <c:crosses val="autoZero"/>
        <c:auto val="1"/>
        <c:lblAlgn val="ctr"/>
        <c:lblOffset val="100"/>
        <c:noMultiLvlLbl val="0"/>
      </c:catAx>
      <c:valAx>
        <c:axId val="1736934944"/>
        <c:scaling>
          <c:orientation val="minMax"/>
          <c:max val="2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736931616"/>
        <c:crosses val="autoZero"/>
        <c:crossBetween val="between"/>
        <c:majorUnit val="8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sis!$H$14</c:f>
              <c:strCache>
                <c:ptCount val="1"/>
                <c:pt idx="0">
                  <c:v>AVE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526-491A-92C3-D1EC768799BA}"/>
              </c:ext>
            </c:extLst>
          </c:dPt>
          <c:dPt>
            <c:idx val="1"/>
            <c:invertIfNegative val="0"/>
            <c:bubble3D val="0"/>
            <c:spPr>
              <a:noFill/>
              <a:ln w="19050">
                <a:solidFill>
                  <a:srgbClr val="E46C0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526-491A-92C3-D1EC768799BA}"/>
              </c:ext>
            </c:extLst>
          </c:dPt>
          <c:errBars>
            <c:errBarType val="plus"/>
            <c:errValType val="cust"/>
            <c:noEndCap val="0"/>
            <c:plus>
              <c:numRef>
                <c:f>analysis!$I$15:$I$16</c:f>
                <c:numCache>
                  <c:formatCode>General</c:formatCode>
                  <c:ptCount val="2"/>
                  <c:pt idx="0">
                    <c:v>11.069036163130132</c:v>
                  </c:pt>
                  <c:pt idx="1">
                    <c:v>8.25172679613417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nalysis!$G$15:$G$16</c:f>
              <c:strCache>
                <c:ptCount val="2"/>
                <c:pt idx="0">
                  <c:v>CTL</c:v>
                </c:pt>
                <c:pt idx="1">
                  <c:v>KO</c:v>
                </c:pt>
              </c:strCache>
            </c:strRef>
          </c:cat>
          <c:val>
            <c:numRef>
              <c:f>analysis!$H$15:$H$16</c:f>
              <c:numCache>
                <c:formatCode>General</c:formatCode>
                <c:ptCount val="2"/>
                <c:pt idx="0">
                  <c:v>161.92248425381507</c:v>
                </c:pt>
                <c:pt idx="1">
                  <c:v>124.058803904403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526-491A-92C3-D1EC768799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105996416"/>
        <c:axId val="1106013472"/>
      </c:barChart>
      <c:catAx>
        <c:axId val="1105996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106013472"/>
        <c:crosses val="autoZero"/>
        <c:auto val="1"/>
        <c:lblAlgn val="ctr"/>
        <c:lblOffset val="100"/>
        <c:noMultiLvlLbl val="0"/>
      </c:catAx>
      <c:valAx>
        <c:axId val="1106013472"/>
        <c:scaling>
          <c:orientation val="minMax"/>
          <c:max val="2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10599641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sis!$B$14</c:f>
              <c:strCache>
                <c:ptCount val="1"/>
                <c:pt idx="0">
                  <c:v>AVE</c:v>
                </c:pt>
              </c:strCache>
            </c:strRef>
          </c:tx>
          <c:spPr>
            <a:noFill/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FD7-45AF-9698-53B613FF43BF}"/>
              </c:ext>
            </c:extLst>
          </c:dPt>
          <c:dPt>
            <c:idx val="1"/>
            <c:invertIfNegative val="0"/>
            <c:bubble3D val="0"/>
            <c:spPr>
              <a:noFill/>
              <a:ln w="19050">
                <a:solidFill>
                  <a:srgbClr val="E46C0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FD7-45AF-9698-53B613FF43BF}"/>
              </c:ext>
            </c:extLst>
          </c:dPt>
          <c:errBars>
            <c:errBarType val="plus"/>
            <c:errValType val="cust"/>
            <c:noEndCap val="0"/>
            <c:plus>
              <c:numRef>
                <c:f>analysis!$C$15:$C$16</c:f>
                <c:numCache>
                  <c:formatCode>General</c:formatCode>
                  <c:ptCount val="2"/>
                  <c:pt idx="0">
                    <c:v>0.31578473680657837</c:v>
                  </c:pt>
                  <c:pt idx="1">
                    <c:v>0.205426385841741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nalysis!$A$15:$A$16</c:f>
              <c:strCache>
                <c:ptCount val="2"/>
                <c:pt idx="0">
                  <c:v>CTL</c:v>
                </c:pt>
                <c:pt idx="1">
                  <c:v>KO</c:v>
                </c:pt>
              </c:strCache>
            </c:strRef>
          </c:cat>
          <c:val>
            <c:numRef>
              <c:f>analysis!$B$15:$B$16</c:f>
              <c:numCache>
                <c:formatCode>General</c:formatCode>
                <c:ptCount val="2"/>
                <c:pt idx="0">
                  <c:v>2.8679999999999999</c:v>
                </c:pt>
                <c:pt idx="1">
                  <c:v>2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FD7-45AF-9698-53B613FF43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165518751"/>
        <c:axId val="1165516671"/>
      </c:barChart>
      <c:catAx>
        <c:axId val="116551875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165516671"/>
        <c:crosses val="autoZero"/>
        <c:auto val="1"/>
        <c:lblAlgn val="ctr"/>
        <c:lblOffset val="100"/>
        <c:noMultiLvlLbl val="0"/>
      </c:catAx>
      <c:valAx>
        <c:axId val="1165516671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16551875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9050">
              <a:solidFill>
                <a:srgbClr val="E46C0A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noFill/>
              <a:ln w="19050">
                <a:solidFill>
                  <a:srgbClr val="77933C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02A-4DD5-A793-B3D7FF58AD9C}"/>
              </c:ext>
            </c:extLst>
          </c:dPt>
          <c:errBars>
            <c:errBarType val="plus"/>
            <c:errValType val="cust"/>
            <c:noEndCap val="0"/>
            <c:plus>
              <c:numRef>
                <c:f>统计!$C$14:$C$15</c:f>
                <c:numCache>
                  <c:formatCode>General</c:formatCode>
                  <c:ptCount val="2"/>
                  <c:pt idx="0">
                    <c:v>0.24355697485393421</c:v>
                  </c:pt>
                  <c:pt idx="1">
                    <c:v>0.466619045189254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统计!$A$14:$A$15</c:f>
              <c:strCache>
                <c:ptCount val="2"/>
                <c:pt idx="0">
                  <c:v>CTL</c:v>
                </c:pt>
                <c:pt idx="1">
                  <c:v>DEA NONOate</c:v>
                </c:pt>
              </c:strCache>
            </c:strRef>
          </c:cat>
          <c:val>
            <c:numRef>
              <c:f>统计!$B$14:$B$15</c:f>
              <c:numCache>
                <c:formatCode>General</c:formatCode>
                <c:ptCount val="2"/>
                <c:pt idx="0">
                  <c:v>2.5720000000000001</c:v>
                </c:pt>
                <c:pt idx="1">
                  <c:v>2.05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2A-4DD5-A793-B3D7FF58AD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843798720"/>
        <c:axId val="1843799136"/>
      </c:barChart>
      <c:catAx>
        <c:axId val="1843798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43799136"/>
        <c:crosses val="autoZero"/>
        <c:auto val="1"/>
        <c:lblAlgn val="ctr"/>
        <c:lblOffset val="100"/>
        <c:noMultiLvlLbl val="0"/>
      </c:catAx>
      <c:valAx>
        <c:axId val="1843799136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84379872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B29721-A363-4FA3-9E2C-56891A475333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F2F335-5CFE-4E61-B7FF-9AF214C2F7E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F2F335-5CFE-4E61-B7FF-9AF214C2F7E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6441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7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80"/>
            <a:ext cx="5669756" cy="2581379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2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2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5"/>
            <a:ext cx="6520220" cy="2338833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2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7" y="2620980"/>
            <a:ext cx="3213847" cy="1284502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7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8" y="1539427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8" y="1539427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2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FF94A-2537-46A6-A49E-054F21036972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7D4B-6455-4E31-8307-30391561F63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chart" Target="../charts/chart3.xml"/><Relationship Id="rId3" Type="http://schemas.openxmlformats.org/officeDocument/2006/relationships/chart" Target="../charts/chart1.xml"/><Relationship Id="rId7" Type="http://schemas.openxmlformats.org/officeDocument/2006/relationships/image" Target="../media/image2.png"/><Relationship Id="rId12" Type="http://schemas.microsoft.com/office/2007/relationships/hdphoto" Target="../media/hdphoto4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4.png"/><Relationship Id="rId5" Type="http://schemas.openxmlformats.org/officeDocument/2006/relationships/image" Target="../media/image1.png"/><Relationship Id="rId10" Type="http://schemas.microsoft.com/office/2007/relationships/hdphoto" Target="../media/hdphoto3.wdp"/><Relationship Id="rId4" Type="http://schemas.openxmlformats.org/officeDocument/2006/relationships/chart" Target="../charts/chart2.xml"/><Relationship Id="rId9" Type="http://schemas.openxmlformats.org/officeDocument/2006/relationships/image" Target="../media/image3.png"/><Relationship Id="rId1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>
            <a:extLst>
              <a:ext uri="{FF2B5EF4-FFF2-40B4-BE49-F238E27FC236}">
                <a16:creationId xmlns:a16="http://schemas.microsoft.com/office/drawing/2014/main" id="{0FE0B86F-FDBD-04C4-45C9-4FC4172305B8}"/>
              </a:ext>
            </a:extLst>
          </p:cNvPr>
          <p:cNvGrpSpPr/>
          <p:nvPr/>
        </p:nvGrpSpPr>
        <p:grpSpPr>
          <a:xfrm>
            <a:off x="1499538" y="732037"/>
            <a:ext cx="4749785" cy="2982429"/>
            <a:chOff x="1333186" y="829903"/>
            <a:chExt cx="4749785" cy="2982429"/>
          </a:xfrm>
        </p:grpSpPr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53588E3-48C8-ECA8-E5CB-6C61AE1C2086}"/>
                </a:ext>
              </a:extLst>
            </p:cNvPr>
            <p:cNvSpPr txBox="1"/>
            <p:nvPr/>
          </p:nvSpPr>
          <p:spPr>
            <a:xfrm>
              <a:off x="3515842" y="829903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DE3D6725-0A26-CB37-85BF-2DE3BC32DA9F}"/>
                </a:ext>
              </a:extLst>
            </p:cNvPr>
            <p:cNvSpPr txBox="1"/>
            <p:nvPr/>
          </p:nvSpPr>
          <p:spPr>
            <a:xfrm>
              <a:off x="1333186" y="829903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97FB06D-FC31-BB0B-FC4B-96581D6366EB}"/>
                </a:ext>
              </a:extLst>
            </p:cNvPr>
            <p:cNvSpPr txBox="1"/>
            <p:nvPr/>
          </p:nvSpPr>
          <p:spPr>
            <a:xfrm>
              <a:off x="3515842" y="2526768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8960B2FF-EA15-3447-7712-CB318BF5B8E9}"/>
                </a:ext>
              </a:extLst>
            </p:cNvPr>
            <p:cNvSpPr txBox="1"/>
            <p:nvPr/>
          </p:nvSpPr>
          <p:spPr>
            <a:xfrm>
              <a:off x="1333186" y="2526768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6668D2DF-302F-2271-229A-89E0EE44EC9C}"/>
                </a:ext>
              </a:extLst>
            </p:cNvPr>
            <p:cNvGrpSpPr/>
            <p:nvPr/>
          </p:nvGrpSpPr>
          <p:grpSpPr>
            <a:xfrm>
              <a:off x="3777305" y="2601956"/>
              <a:ext cx="1131053" cy="1151005"/>
              <a:chOff x="2965923" y="1162344"/>
              <a:chExt cx="1131053" cy="1151005"/>
            </a:xfrm>
          </p:grpSpPr>
          <p:sp>
            <p:nvSpPr>
              <p:cNvPr id="72" name="文本框 8">
                <a:extLst>
                  <a:ext uri="{FF2B5EF4-FFF2-40B4-BE49-F238E27FC236}">
                    <a16:creationId xmlns:a16="http://schemas.microsoft.com/office/drawing/2014/main" id="{E29C9B76-5957-866F-2C51-43D36524C25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0800000">
                <a:off x="2965923" y="1289201"/>
                <a:ext cx="107722" cy="9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 lIns="0" rIns="0" anchor="b">
                <a:spAutoFit/>
              </a:bodyPr>
              <a:lstStyle>
                <a:defPPr>
                  <a:defRPr lang="zh-CN"/>
                </a:defPPr>
                <a:lvl1pPr algn="ctr" defTabSz="1042847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9pPr>
              </a:lstStyle>
              <a:p>
                <a:r>
                  <a:rPr lang="en-US" altLang="zh-CN" dirty="0"/>
                  <a:t>Colony size (μm) </a:t>
                </a:r>
                <a:endParaRPr lang="zh-CN" altLang="en-US" dirty="0"/>
              </a:p>
            </p:txBody>
          </p:sp>
          <p:graphicFrame>
            <p:nvGraphicFramePr>
              <p:cNvPr id="73" name="图表 72">
                <a:extLst>
                  <a:ext uri="{FF2B5EF4-FFF2-40B4-BE49-F238E27FC236}">
                    <a16:creationId xmlns:a16="http://schemas.microsoft.com/office/drawing/2014/main" id="{929EB734-9578-9EBA-7F86-6CC8D5F0C4E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36688365"/>
                  </p:ext>
                </p:extLst>
              </p:nvPr>
            </p:nvGraphicFramePr>
            <p:xfrm>
              <a:off x="3016976" y="1162344"/>
              <a:ext cx="1080000" cy="10809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2B76383C-B9AC-70C6-DEF9-CDDB77C7C819}"/>
                  </a:ext>
                </a:extLst>
              </p:cNvPr>
              <p:cNvSpPr txBox="1"/>
              <p:nvPr/>
            </p:nvSpPr>
            <p:spPr>
              <a:xfrm>
                <a:off x="3636462" y="130893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1400" b="1" dirty="0">
                    <a:cs typeface="Arial" panose="020B0604020202020204" pitchFamily="34" charset="0"/>
                  </a:rPr>
                  <a:t>*</a:t>
                </a:r>
                <a:endParaRPr lang="zh-CN" altLang="en-US" sz="14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596161B0-6DA8-D5A2-C90B-066F0A9069AC}"/>
                  </a:ext>
                </a:extLst>
              </p:cNvPr>
              <p:cNvSpPr txBox="1"/>
              <p:nvPr/>
            </p:nvSpPr>
            <p:spPr>
              <a:xfrm rot="19315933">
                <a:off x="3034360" y="2199952"/>
                <a:ext cx="547654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5A12A080-45FE-68F5-6F3C-9AC7A2611CE5}"/>
                  </a:ext>
                </a:extLst>
              </p:cNvPr>
              <p:cNvSpPr txBox="1"/>
              <p:nvPr/>
            </p:nvSpPr>
            <p:spPr>
              <a:xfrm rot="19315933">
                <a:off x="3340348" y="2205627"/>
                <a:ext cx="579258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530669E3-22E1-4F6E-BB85-C9AE3CAE1B80}"/>
                </a:ext>
              </a:extLst>
            </p:cNvPr>
            <p:cNvGrpSpPr/>
            <p:nvPr/>
          </p:nvGrpSpPr>
          <p:grpSpPr>
            <a:xfrm>
              <a:off x="3620597" y="937859"/>
              <a:ext cx="1277464" cy="1230269"/>
              <a:chOff x="2841871" y="2521943"/>
              <a:chExt cx="1277464" cy="1230269"/>
            </a:xfrm>
          </p:grpSpPr>
          <p:sp>
            <p:nvSpPr>
              <p:cNvPr id="67" name="文本框 8">
                <a:extLst>
                  <a:ext uri="{FF2B5EF4-FFF2-40B4-BE49-F238E27FC236}">
                    <a16:creationId xmlns:a16="http://schemas.microsoft.com/office/drawing/2014/main" id="{6A158E86-88AF-C464-9B40-8E5358F06B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0800000">
                <a:off x="2974979" y="2597924"/>
                <a:ext cx="107722" cy="9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 lIns="0" rIns="0" anchor="b">
                <a:spAutoFit/>
              </a:bodyPr>
              <a:lstStyle>
                <a:defPPr>
                  <a:defRPr lang="zh-CN"/>
                </a:defPPr>
                <a:lvl1pPr algn="ctr" defTabSz="1042847">
                  <a:lnSpc>
                    <a:spcPct val="100000"/>
                  </a:lnSpc>
                  <a:spcBef>
                    <a:spcPct val="0"/>
                  </a:spcBef>
                  <a:buFont typeface="Arial" panose="020B0604020202020204" pitchFamily="34" charset="0"/>
                  <a:buNone/>
                  <a:defRPr sz="700">
                    <a:solidFill>
                      <a:prstClr val="black"/>
                    </a:solidFill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latin typeface="Calibri" panose="020F0502020204030204" pitchFamily="34" charset="0"/>
                  </a:defRPr>
                </a:lvl9pPr>
              </a:lstStyle>
              <a:p>
                <a:r>
                  <a:rPr lang="en-US" altLang="zh-CN" dirty="0"/>
                  <a:t>Colony size (μm) </a:t>
                </a:r>
                <a:endParaRPr lang="zh-CN" altLang="en-US" dirty="0"/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865362A1-08FA-FDE8-A225-AF5645313201}"/>
                  </a:ext>
                </a:extLst>
              </p:cNvPr>
              <p:cNvSpPr txBox="1"/>
              <p:nvPr/>
            </p:nvSpPr>
            <p:spPr>
              <a:xfrm rot="19566848">
                <a:off x="2841871" y="3644490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C63962F5-98DE-BFE7-6012-D684688D176C}"/>
                  </a:ext>
                </a:extLst>
              </p:cNvPr>
              <p:cNvSpPr txBox="1"/>
              <p:nvPr/>
            </p:nvSpPr>
            <p:spPr>
              <a:xfrm rot="19566848">
                <a:off x="3154305" y="3644489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70" name="图表 69">
                <a:extLst>
                  <a:ext uri="{FF2B5EF4-FFF2-40B4-BE49-F238E27FC236}">
                    <a16:creationId xmlns:a16="http://schemas.microsoft.com/office/drawing/2014/main" id="{BB645197-3BF0-4C78-6008-FF16902D478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45210547"/>
                  </p:ext>
                </p:extLst>
              </p:nvPr>
            </p:nvGraphicFramePr>
            <p:xfrm>
              <a:off x="3039335" y="2521943"/>
              <a:ext cx="1080000" cy="108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71" name="TextBox 129">
                <a:extLst>
                  <a:ext uri="{FF2B5EF4-FFF2-40B4-BE49-F238E27FC236}">
                    <a16:creationId xmlns:a16="http://schemas.microsoft.com/office/drawing/2014/main" id="{C039FEA8-7AC0-EC3B-630A-140D97926DAE}"/>
                  </a:ext>
                </a:extLst>
              </p:cNvPr>
              <p:cNvSpPr txBox="1"/>
              <p:nvPr/>
            </p:nvSpPr>
            <p:spPr>
              <a:xfrm>
                <a:off x="3534156" y="2761982"/>
                <a:ext cx="573487" cy="21544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>
                  <a:defRPr/>
                </a:pPr>
                <a:r>
                  <a:rPr lang="en-US" altLang="zh-CN" sz="1400" kern="0" dirty="0">
                    <a:solidFill>
                      <a:prstClr val="black"/>
                    </a:solidFill>
                    <a:cs typeface="Arial" panose="020B0604020202020204" pitchFamily="34" charset="0"/>
                  </a:rPr>
                  <a:t>****</a:t>
                </a:r>
                <a:endParaRPr lang="zh-CN" altLang="en-US" sz="1400" kern="0" dirty="0">
                  <a:solidFill>
                    <a:prstClr val="black"/>
                  </a:solidFill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3FB90C1A-E343-995A-B25E-A93DBDAD46F1}"/>
                </a:ext>
              </a:extLst>
            </p:cNvPr>
            <p:cNvGrpSpPr/>
            <p:nvPr/>
          </p:nvGrpSpPr>
          <p:grpSpPr>
            <a:xfrm>
              <a:off x="1556162" y="1024221"/>
              <a:ext cx="2016000" cy="1162183"/>
              <a:chOff x="749577" y="941671"/>
              <a:chExt cx="2016000" cy="1162183"/>
            </a:xfrm>
          </p:grpSpPr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DCD30123-C416-9E8E-96C4-0ECB90D2D5EE}"/>
                  </a:ext>
                </a:extLst>
              </p:cNvPr>
              <p:cNvSpPr txBox="1"/>
              <p:nvPr/>
            </p:nvSpPr>
            <p:spPr>
              <a:xfrm>
                <a:off x="779037" y="941671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7AF61CB1-4A12-366E-1208-BE84D8DF4B3D}"/>
                  </a:ext>
                </a:extLst>
              </p:cNvPr>
              <p:cNvSpPr txBox="1"/>
              <p:nvPr/>
            </p:nvSpPr>
            <p:spPr>
              <a:xfrm>
                <a:off x="1789380" y="941671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1" name="组合 60">
                <a:extLst>
                  <a:ext uri="{FF2B5EF4-FFF2-40B4-BE49-F238E27FC236}">
                    <a16:creationId xmlns:a16="http://schemas.microsoft.com/office/drawing/2014/main" id="{CC8A05E0-755C-0034-9F95-D22CE1F09193}"/>
                  </a:ext>
                </a:extLst>
              </p:cNvPr>
              <p:cNvGrpSpPr/>
              <p:nvPr/>
            </p:nvGrpSpPr>
            <p:grpSpPr>
              <a:xfrm>
                <a:off x="749577" y="1095854"/>
                <a:ext cx="1008000" cy="1008000"/>
                <a:chOff x="-148418" y="577157"/>
                <a:chExt cx="1584000" cy="1584000"/>
              </a:xfrm>
            </p:grpSpPr>
            <p:pic>
              <p:nvPicPr>
                <p:cNvPr id="65" name="图片 64">
                  <a:extLst>
                    <a:ext uri="{FF2B5EF4-FFF2-40B4-BE49-F238E27FC236}">
                      <a16:creationId xmlns:a16="http://schemas.microsoft.com/office/drawing/2014/main" id="{499BC931-1AC3-08FC-D0D8-75384226BB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sharpenSoften amount="50000"/>
                          </a14:imgEffect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050" t="7161" r="5530" b="4839"/>
                <a:stretch>
                  <a:fillRect/>
                </a:stretch>
              </p:blipFill>
              <p:spPr>
                <a:xfrm>
                  <a:off x="-148418" y="577157"/>
                  <a:ext cx="1584000" cy="1584000"/>
                </a:xfrm>
                <a:custGeom>
                  <a:avLst/>
                  <a:gdLst>
                    <a:gd name="connsiteX0" fmla="*/ 792000 w 1584000"/>
                    <a:gd name="connsiteY0" fmla="*/ 0 h 1584000"/>
                    <a:gd name="connsiteX1" fmla="*/ 1584000 w 1584000"/>
                    <a:gd name="connsiteY1" fmla="*/ 792000 h 1584000"/>
                    <a:gd name="connsiteX2" fmla="*/ 792000 w 1584000"/>
                    <a:gd name="connsiteY2" fmla="*/ 1584000 h 1584000"/>
                    <a:gd name="connsiteX3" fmla="*/ 0 w 1584000"/>
                    <a:gd name="connsiteY3" fmla="*/ 792000 h 1584000"/>
                    <a:gd name="connsiteX4" fmla="*/ 792000 w 1584000"/>
                    <a:gd name="connsiteY4" fmla="*/ 0 h 15840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584000" h="1584000">
                      <a:moveTo>
                        <a:pt x="792000" y="0"/>
                      </a:moveTo>
                      <a:cubicBezTo>
                        <a:pt x="1229410" y="0"/>
                        <a:pt x="1584000" y="354590"/>
                        <a:pt x="1584000" y="792000"/>
                      </a:cubicBezTo>
                      <a:cubicBezTo>
                        <a:pt x="1584000" y="1229410"/>
                        <a:pt x="1229410" y="1584000"/>
                        <a:pt x="792000" y="1584000"/>
                      </a:cubicBezTo>
                      <a:cubicBezTo>
                        <a:pt x="354590" y="1584000"/>
                        <a:pt x="0" y="1229410"/>
                        <a:pt x="0" y="792000"/>
                      </a:cubicBezTo>
                      <a:cubicBezTo>
                        <a:pt x="0" y="354590"/>
                        <a:pt x="354590" y="0"/>
                        <a:pt x="792000" y="0"/>
                      </a:cubicBezTo>
                      <a:close/>
                    </a:path>
                  </a:pathLst>
                </a:custGeom>
                <a:ln w="28575">
                  <a:noFill/>
                </a:ln>
              </p:spPr>
            </p:pic>
            <p:cxnSp>
              <p:nvCxnSpPr>
                <p:cNvPr id="66" name="直接连接符 65">
                  <a:extLst>
                    <a:ext uri="{FF2B5EF4-FFF2-40B4-BE49-F238E27FC236}">
                      <a16:creationId xmlns:a16="http://schemas.microsoft.com/office/drawing/2014/main" id="{80579ED3-350E-C8FA-3360-257387B06529}"/>
                    </a:ext>
                  </a:extLst>
                </p:cNvPr>
                <p:cNvCxnSpPr/>
                <p:nvPr/>
              </p:nvCxnSpPr>
              <p:spPr>
                <a:xfrm>
                  <a:off x="559548" y="2090081"/>
                  <a:ext cx="2052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5D638DBE-CAF0-C7E0-E021-ADA8D1741B73}"/>
                  </a:ext>
                </a:extLst>
              </p:cNvPr>
              <p:cNvGrpSpPr/>
              <p:nvPr/>
            </p:nvGrpSpPr>
            <p:grpSpPr>
              <a:xfrm>
                <a:off x="1757577" y="1095854"/>
                <a:ext cx="1008000" cy="1008000"/>
                <a:chOff x="5675221" y="2397162"/>
                <a:chExt cx="1584000" cy="1584000"/>
              </a:xfrm>
            </p:grpSpPr>
            <p:pic>
              <p:nvPicPr>
                <p:cNvPr id="63" name="图片 62">
                  <a:extLst>
                    <a:ext uri="{FF2B5EF4-FFF2-40B4-BE49-F238E27FC236}">
                      <a16:creationId xmlns:a16="http://schemas.microsoft.com/office/drawing/2014/main" id="{FF292E04-D74E-345A-8E50-CF7DE4246FB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sharpenSoften amount="50000"/>
                          </a14:imgEffect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52" t="6474" r="5853" b="5526"/>
                <a:stretch>
                  <a:fillRect/>
                </a:stretch>
              </p:blipFill>
              <p:spPr>
                <a:xfrm>
                  <a:off x="5675221" y="2397162"/>
                  <a:ext cx="1584000" cy="1584000"/>
                </a:xfrm>
                <a:custGeom>
                  <a:avLst/>
                  <a:gdLst>
                    <a:gd name="connsiteX0" fmla="*/ 792000 w 1584000"/>
                    <a:gd name="connsiteY0" fmla="*/ 0 h 1584000"/>
                    <a:gd name="connsiteX1" fmla="*/ 1584000 w 1584000"/>
                    <a:gd name="connsiteY1" fmla="*/ 792000 h 1584000"/>
                    <a:gd name="connsiteX2" fmla="*/ 792000 w 1584000"/>
                    <a:gd name="connsiteY2" fmla="*/ 1584000 h 1584000"/>
                    <a:gd name="connsiteX3" fmla="*/ 0 w 1584000"/>
                    <a:gd name="connsiteY3" fmla="*/ 792000 h 1584000"/>
                    <a:gd name="connsiteX4" fmla="*/ 792000 w 1584000"/>
                    <a:gd name="connsiteY4" fmla="*/ 0 h 15840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1584000" h="1584000">
                      <a:moveTo>
                        <a:pt x="792000" y="0"/>
                      </a:moveTo>
                      <a:cubicBezTo>
                        <a:pt x="1229410" y="0"/>
                        <a:pt x="1584000" y="354590"/>
                        <a:pt x="1584000" y="792000"/>
                      </a:cubicBezTo>
                      <a:cubicBezTo>
                        <a:pt x="1584000" y="1229410"/>
                        <a:pt x="1229410" y="1584000"/>
                        <a:pt x="792000" y="1584000"/>
                      </a:cubicBezTo>
                      <a:cubicBezTo>
                        <a:pt x="354590" y="1584000"/>
                        <a:pt x="0" y="1229410"/>
                        <a:pt x="0" y="792000"/>
                      </a:cubicBezTo>
                      <a:cubicBezTo>
                        <a:pt x="0" y="354590"/>
                        <a:pt x="354590" y="0"/>
                        <a:pt x="792000" y="0"/>
                      </a:cubicBezTo>
                      <a:close/>
                    </a:path>
                  </a:pathLst>
                </a:custGeom>
                <a:ln w="28575">
                  <a:noFill/>
                </a:ln>
              </p:spPr>
            </p:pic>
            <p:cxnSp>
              <p:nvCxnSpPr>
                <p:cNvPr id="64" name="直接连接符 63">
                  <a:extLst>
                    <a:ext uri="{FF2B5EF4-FFF2-40B4-BE49-F238E27FC236}">
                      <a16:creationId xmlns:a16="http://schemas.microsoft.com/office/drawing/2014/main" id="{BDB0D65E-C215-1808-C842-4174FA83205E}"/>
                    </a:ext>
                  </a:extLst>
                </p:cNvPr>
                <p:cNvCxnSpPr/>
                <p:nvPr/>
              </p:nvCxnSpPr>
              <p:spPr>
                <a:xfrm>
                  <a:off x="6364621" y="3875240"/>
                  <a:ext cx="2052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93FAB390-62CC-A74C-D937-DB9FB9CE1334}"/>
                </a:ext>
              </a:extLst>
            </p:cNvPr>
            <p:cNvGrpSpPr/>
            <p:nvPr/>
          </p:nvGrpSpPr>
          <p:grpSpPr>
            <a:xfrm>
              <a:off x="1496935" y="2644142"/>
              <a:ext cx="2041376" cy="1168190"/>
              <a:chOff x="642347" y="2707908"/>
              <a:chExt cx="2041376" cy="1168190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240F31B0-5BE6-0237-AC9D-7CCA26C378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33" t="12313" r="10689" b="9909"/>
              <a:stretch>
                <a:fillRect/>
              </a:stretch>
            </p:blipFill>
            <p:spPr>
              <a:xfrm>
                <a:off x="642347" y="2867240"/>
                <a:ext cx="1008000" cy="1008000"/>
              </a:xfrm>
              <a:custGeom>
                <a:avLst/>
                <a:gdLst>
                  <a:gd name="connsiteX0" fmla="*/ 630000 w 1260000"/>
                  <a:gd name="connsiteY0" fmla="*/ 0 h 1260000"/>
                  <a:gd name="connsiteX1" fmla="*/ 1260000 w 1260000"/>
                  <a:gd name="connsiteY1" fmla="*/ 630000 h 1260000"/>
                  <a:gd name="connsiteX2" fmla="*/ 630000 w 1260000"/>
                  <a:gd name="connsiteY2" fmla="*/ 1260000 h 1260000"/>
                  <a:gd name="connsiteX3" fmla="*/ 0 w 1260000"/>
                  <a:gd name="connsiteY3" fmla="*/ 630000 h 1260000"/>
                  <a:gd name="connsiteX4" fmla="*/ 630000 w 1260000"/>
                  <a:gd name="connsiteY4" fmla="*/ 0 h 12600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260000" h="1260000">
                    <a:moveTo>
                      <a:pt x="630000" y="0"/>
                    </a:moveTo>
                    <a:cubicBezTo>
                      <a:pt x="977939" y="0"/>
                      <a:pt x="1260000" y="282061"/>
                      <a:pt x="1260000" y="630000"/>
                    </a:cubicBezTo>
                    <a:cubicBezTo>
                      <a:pt x="1260000" y="977939"/>
                      <a:pt x="977939" y="1260000"/>
                      <a:pt x="630000" y="1260000"/>
                    </a:cubicBezTo>
                    <a:cubicBezTo>
                      <a:pt x="282061" y="1260000"/>
                      <a:pt x="0" y="977939"/>
                      <a:pt x="0" y="630000"/>
                    </a:cubicBezTo>
                    <a:cubicBezTo>
                      <a:pt x="0" y="282061"/>
                      <a:pt x="282061" y="0"/>
                      <a:pt x="630000" y="0"/>
                    </a:cubicBezTo>
                    <a:close/>
                  </a:path>
                </a:pathLst>
              </a:cu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670F3906-0794-6EBB-405A-1798E5D191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86" t="10785" r="12384" b="11437"/>
              <a:stretch>
                <a:fillRect/>
              </a:stretch>
            </p:blipFill>
            <p:spPr>
              <a:xfrm>
                <a:off x="1675723" y="2868098"/>
                <a:ext cx="1008000" cy="1008000"/>
              </a:xfrm>
              <a:custGeom>
                <a:avLst/>
                <a:gdLst>
                  <a:gd name="connsiteX0" fmla="*/ 630000 w 1260000"/>
                  <a:gd name="connsiteY0" fmla="*/ 0 h 1260000"/>
                  <a:gd name="connsiteX1" fmla="*/ 1260000 w 1260000"/>
                  <a:gd name="connsiteY1" fmla="*/ 630000 h 1260000"/>
                  <a:gd name="connsiteX2" fmla="*/ 630000 w 1260000"/>
                  <a:gd name="connsiteY2" fmla="*/ 1260000 h 1260000"/>
                  <a:gd name="connsiteX3" fmla="*/ 0 w 1260000"/>
                  <a:gd name="connsiteY3" fmla="*/ 630000 h 1260000"/>
                  <a:gd name="connsiteX4" fmla="*/ 630000 w 1260000"/>
                  <a:gd name="connsiteY4" fmla="*/ 0 h 12600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260000" h="1260000">
                    <a:moveTo>
                      <a:pt x="630000" y="0"/>
                    </a:moveTo>
                    <a:cubicBezTo>
                      <a:pt x="977939" y="0"/>
                      <a:pt x="1260000" y="282061"/>
                      <a:pt x="1260000" y="630000"/>
                    </a:cubicBezTo>
                    <a:cubicBezTo>
                      <a:pt x="1260000" y="977939"/>
                      <a:pt x="977939" y="1260000"/>
                      <a:pt x="630000" y="1260000"/>
                    </a:cubicBezTo>
                    <a:cubicBezTo>
                      <a:pt x="282061" y="1260000"/>
                      <a:pt x="0" y="977939"/>
                      <a:pt x="0" y="630000"/>
                    </a:cubicBezTo>
                    <a:cubicBezTo>
                      <a:pt x="0" y="282061"/>
                      <a:pt x="282061" y="0"/>
                      <a:pt x="630000" y="0"/>
                    </a:cubicBezTo>
                    <a:close/>
                  </a:path>
                </a:pathLst>
              </a:custGeom>
            </p:spPr>
          </p:pic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AD8A660F-0B56-7BEA-4ED8-46683E0FACB3}"/>
                  </a:ext>
                </a:extLst>
              </p:cNvPr>
              <p:cNvSpPr txBox="1"/>
              <p:nvPr/>
            </p:nvSpPr>
            <p:spPr>
              <a:xfrm>
                <a:off x="704946" y="2707908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15219A23-AC98-1D84-6509-128F277B5E4F}"/>
                  </a:ext>
                </a:extLst>
              </p:cNvPr>
              <p:cNvSpPr txBox="1"/>
              <p:nvPr/>
            </p:nvSpPr>
            <p:spPr>
              <a:xfrm>
                <a:off x="1734828" y="2713915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ECB79774-3B10-5CB7-E8EA-6B1A1E8B98D9}"/>
                  </a:ext>
                </a:extLst>
              </p:cNvPr>
              <p:cNvCxnSpPr/>
              <p:nvPr/>
            </p:nvCxnSpPr>
            <p:spPr>
              <a:xfrm>
                <a:off x="1095539" y="3816189"/>
                <a:ext cx="13058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>
                <a:extLst>
                  <a:ext uri="{FF2B5EF4-FFF2-40B4-BE49-F238E27FC236}">
                    <a16:creationId xmlns:a16="http://schemas.microsoft.com/office/drawing/2014/main" id="{33B1C3D3-1437-7E6B-E55C-2ED09FDD4D1E}"/>
                  </a:ext>
                </a:extLst>
              </p:cNvPr>
              <p:cNvCxnSpPr/>
              <p:nvPr/>
            </p:nvCxnSpPr>
            <p:spPr>
              <a:xfrm>
                <a:off x="2134452" y="3814755"/>
                <a:ext cx="130582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76EDDE7B-66B4-ED80-3A5D-8981AB37BF4C}"/>
                </a:ext>
              </a:extLst>
            </p:cNvPr>
            <p:cNvGrpSpPr/>
            <p:nvPr/>
          </p:nvGrpSpPr>
          <p:grpSpPr>
            <a:xfrm>
              <a:off x="4799805" y="947290"/>
              <a:ext cx="1283166" cy="1233628"/>
              <a:chOff x="9337576" y="1149826"/>
              <a:chExt cx="1283166" cy="1233628"/>
            </a:xfrm>
          </p:grpSpPr>
          <p:sp>
            <p:nvSpPr>
              <p:cNvPr id="47" name="文本框 16">
                <a:extLst>
                  <a:ext uri="{FF2B5EF4-FFF2-40B4-BE49-F238E27FC236}">
                    <a16:creationId xmlns:a16="http://schemas.microsoft.com/office/drawing/2014/main" id="{8325132A-73CF-83C9-029E-1974C18D1ED6}"/>
                  </a:ext>
                </a:extLst>
              </p:cNvPr>
              <p:cNvSpPr txBox="1"/>
              <p:nvPr/>
            </p:nvSpPr>
            <p:spPr>
              <a:xfrm rot="19566848">
                <a:off x="9337576" y="2275732"/>
                <a:ext cx="913221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dpd2 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X</a:t>
                </a:r>
                <a:r>
                  <a:rPr lang="en-US" altLang="zh-CN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zh-CN" alt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8" name="组合 47">
                <a:extLst>
                  <a:ext uri="{FF2B5EF4-FFF2-40B4-BE49-F238E27FC236}">
                    <a16:creationId xmlns:a16="http://schemas.microsoft.com/office/drawing/2014/main" id="{334D39CC-739C-64BE-627D-15BEEF238F93}"/>
                  </a:ext>
                </a:extLst>
              </p:cNvPr>
              <p:cNvGrpSpPr/>
              <p:nvPr/>
            </p:nvGrpSpPr>
            <p:grpSpPr>
              <a:xfrm>
                <a:off x="9537930" y="1149826"/>
                <a:ext cx="1082812" cy="1233627"/>
                <a:chOff x="5703751" y="863499"/>
                <a:chExt cx="1082812" cy="1233627"/>
              </a:xfrm>
            </p:grpSpPr>
            <p:graphicFrame>
              <p:nvGraphicFramePr>
                <p:cNvPr id="49" name="图表 48">
                  <a:extLst>
                    <a:ext uri="{FF2B5EF4-FFF2-40B4-BE49-F238E27FC236}">
                      <a16:creationId xmlns:a16="http://schemas.microsoft.com/office/drawing/2014/main" id="{BA24799E-22D3-618E-53D4-CE90D7BBFF67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38807174"/>
                    </p:ext>
                  </p:extLst>
                </p:nvPr>
              </p:nvGraphicFramePr>
              <p:xfrm>
                <a:off x="5784456" y="863499"/>
                <a:ext cx="1002107" cy="108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  <p:sp>
              <p:nvSpPr>
                <p:cNvPr id="50" name="文本框 215">
                  <a:extLst>
                    <a:ext uri="{FF2B5EF4-FFF2-40B4-BE49-F238E27FC236}">
                      <a16:creationId xmlns:a16="http://schemas.microsoft.com/office/drawing/2014/main" id="{97DCF186-3BA0-E798-6068-3FCFC381075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5400000" flipV="1">
                  <a:off x="5455047" y="1328372"/>
                  <a:ext cx="605129" cy="1077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lIns="0" tIns="0" rIns="0" bIns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FE</a:t>
                  </a:r>
                  <a:r>
                    <a:rPr lang="en-US" altLang="zh-CN" sz="700" kern="0" dirty="0">
                      <a:solidFill>
                        <a:prstClr val="black"/>
                      </a:solidFill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altLang="zh-CN" sz="700" kern="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(%)</a:t>
                  </a:r>
                  <a:endParaRPr lang="zh-CN" altLang="en-US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TextBox 129">
                  <a:extLst>
                    <a:ext uri="{FF2B5EF4-FFF2-40B4-BE49-F238E27FC236}">
                      <a16:creationId xmlns:a16="http://schemas.microsoft.com/office/drawing/2014/main" id="{77823518-BB09-E0DE-F5AA-505FFB8CE8F7}"/>
                    </a:ext>
                  </a:extLst>
                </p:cNvPr>
                <p:cNvSpPr txBox="1"/>
                <p:nvPr/>
              </p:nvSpPr>
              <p:spPr>
                <a:xfrm>
                  <a:off x="6194897" y="1202346"/>
                  <a:ext cx="573487" cy="21544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US" altLang="zh-CN" sz="1400" kern="0" dirty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***</a:t>
                  </a:r>
                  <a:endParaRPr lang="zh-CN" altLang="en-US" sz="1400" kern="0" dirty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" name="文本框 18">
                  <a:extLst>
                    <a:ext uri="{FF2B5EF4-FFF2-40B4-BE49-F238E27FC236}">
                      <a16:creationId xmlns:a16="http://schemas.microsoft.com/office/drawing/2014/main" id="{AED9741E-35A8-9A1E-3D76-724FA3B5CA87}"/>
                    </a:ext>
                  </a:extLst>
                </p:cNvPr>
                <p:cNvSpPr txBox="1"/>
                <p:nvPr/>
              </p:nvSpPr>
              <p:spPr>
                <a:xfrm rot="19566848">
                  <a:off x="5815831" y="1989404"/>
                  <a:ext cx="913221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dpd2 X</a:t>
                  </a:r>
                  <a:r>
                    <a:rPr lang="en-US" altLang="zh-CN" sz="7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X</a:t>
                  </a:r>
                  <a:r>
                    <a:rPr lang="en-US" altLang="zh-CN" sz="7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endParaRPr lang="zh-CN" alt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877F95D3-30EF-262B-8A13-DE794577482A}"/>
                </a:ext>
              </a:extLst>
            </p:cNvPr>
            <p:cNvSpPr txBox="1"/>
            <p:nvPr/>
          </p:nvSpPr>
          <p:spPr>
            <a:xfrm>
              <a:off x="4813205" y="829903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E41FA86-67F8-1088-E8B4-F8578A8E8BFB}"/>
                </a:ext>
              </a:extLst>
            </p:cNvPr>
            <p:cNvSpPr txBox="1"/>
            <p:nvPr/>
          </p:nvSpPr>
          <p:spPr>
            <a:xfrm>
              <a:off x="4813205" y="2530207"/>
              <a:ext cx="30308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C8292077-9DC1-605D-1E83-04607E9DF2C8}"/>
                </a:ext>
              </a:extLst>
            </p:cNvPr>
            <p:cNvGrpSpPr/>
            <p:nvPr/>
          </p:nvGrpSpPr>
          <p:grpSpPr>
            <a:xfrm>
              <a:off x="4996563" y="2659699"/>
              <a:ext cx="1074725" cy="1109431"/>
              <a:chOff x="4958463" y="2659699"/>
              <a:chExt cx="1074725" cy="1109431"/>
            </a:xfrm>
          </p:grpSpPr>
          <p:grpSp>
            <p:nvGrpSpPr>
              <p:cNvPr id="41" name="组合 40">
                <a:extLst>
                  <a:ext uri="{FF2B5EF4-FFF2-40B4-BE49-F238E27FC236}">
                    <a16:creationId xmlns:a16="http://schemas.microsoft.com/office/drawing/2014/main" id="{A4F09B68-1256-FC8A-7A07-8142E114BBF1}"/>
                  </a:ext>
                </a:extLst>
              </p:cNvPr>
              <p:cNvGrpSpPr/>
              <p:nvPr/>
            </p:nvGrpSpPr>
            <p:grpSpPr>
              <a:xfrm>
                <a:off x="4974665" y="2659699"/>
                <a:ext cx="1058523" cy="1109431"/>
                <a:chOff x="4974665" y="2659699"/>
                <a:chExt cx="1058523" cy="1109431"/>
              </a:xfrm>
            </p:grpSpPr>
            <p:graphicFrame>
              <p:nvGraphicFramePr>
                <p:cNvPr id="43" name="图表 42">
                  <a:extLst>
                    <a:ext uri="{FF2B5EF4-FFF2-40B4-BE49-F238E27FC236}">
                      <a16:creationId xmlns:a16="http://schemas.microsoft.com/office/drawing/2014/main" id="{6CF131EC-6208-D677-5412-EE42ED5BA8C7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06518165"/>
                    </p:ext>
                  </p:extLst>
                </p:nvPr>
              </p:nvGraphicFramePr>
              <p:xfrm>
                <a:off x="5054019" y="2659699"/>
                <a:ext cx="979169" cy="97631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4"/>
                </a:graphicData>
              </a:graphic>
            </p:graphicFrame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5DE25C8C-9D57-B03E-DBCF-A0F1429559A3}"/>
                    </a:ext>
                  </a:extLst>
                </p:cNvPr>
                <p:cNvSpPr txBox="1"/>
                <p:nvPr/>
              </p:nvSpPr>
              <p:spPr>
                <a:xfrm rot="19315933">
                  <a:off x="4974665" y="3655733"/>
                  <a:ext cx="547654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dpd2 X</a:t>
                  </a:r>
                  <a:r>
                    <a:rPr lang="en-US" altLang="zh-CN" sz="7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  <a:endParaRPr lang="zh-CN" alt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59810163-7FA6-2319-DB85-E868CACFD26E}"/>
                    </a:ext>
                  </a:extLst>
                </p:cNvPr>
                <p:cNvSpPr txBox="1"/>
                <p:nvPr/>
              </p:nvSpPr>
              <p:spPr>
                <a:xfrm rot="19315933">
                  <a:off x="5280653" y="3661408"/>
                  <a:ext cx="579258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dpd2 X</a:t>
                  </a:r>
                  <a:r>
                    <a:rPr lang="en-US" altLang="zh-CN" sz="7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O</a:t>
                  </a: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</a:t>
                  </a:r>
                  <a:endParaRPr lang="zh-CN" alt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122404A2-24A5-7C02-E224-9895F5F19F5F}"/>
                    </a:ext>
                  </a:extLst>
                </p:cNvPr>
                <p:cNvSpPr txBox="1"/>
                <p:nvPr/>
              </p:nvSpPr>
              <p:spPr>
                <a:xfrm>
                  <a:off x="5572659" y="2769301"/>
                  <a:ext cx="324000" cy="21544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1400" b="1" dirty="0">
                      <a:cs typeface="Arial" panose="020B0604020202020204" pitchFamily="34" charset="0"/>
                    </a:rPr>
                    <a:t>*</a:t>
                  </a:r>
                  <a:endParaRPr lang="zh-CN" altLang="en-US" sz="1400" b="1" dirty="0"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2" name="文本框 215">
                <a:extLst>
                  <a:ext uri="{FF2B5EF4-FFF2-40B4-BE49-F238E27FC236}">
                    <a16:creationId xmlns:a16="http://schemas.microsoft.com/office/drawing/2014/main" id="{EAB2AD23-8050-7F03-6CAB-A237BD74003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5400000" flipV="1">
                <a:off x="4709759" y="3058583"/>
                <a:ext cx="605129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FE</a:t>
                </a:r>
                <a:r>
                  <a:rPr lang="en-US" altLang="zh-CN" sz="700" kern="0" dirty="0">
                    <a:solidFill>
                      <a:prstClr val="black"/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70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zh-CN" altLang="en-US" sz="7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15D6D569-1C4D-A147-1828-F891E16092D8}"/>
              </a:ext>
            </a:extLst>
          </p:cNvPr>
          <p:cNvSpPr txBox="1"/>
          <p:nvPr/>
        </p:nvSpPr>
        <p:spPr>
          <a:xfrm>
            <a:off x="209192" y="4076752"/>
            <a:ext cx="7150397" cy="18368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5.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dpd2 deficiency inhibits club cell proliferation </a:t>
            </a:r>
            <a:r>
              <a:rPr lang="en-US" altLang="zh-CN" sz="1100" b="1" i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n vitro</a:t>
            </a:r>
            <a:r>
              <a:rPr lang="en-US" altLang="zh-CN" sz="1100" b="1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A) Representative images of club cell organoid cultures (stromal-free system) from wide-type mice or Gdpd2 KO (X</a:t>
            </a:r>
            <a:r>
              <a:rPr lang="en-US" altLang="zh-CN" sz="11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O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X</a:t>
            </a:r>
            <a:r>
              <a:rPr lang="en-US" altLang="zh-CN" sz="11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WT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 mice (n=5:5), at day 8 after plating. Scale bar: 500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B, C) Diameter and CFEs of club cell colonies under the conditions described in (A) (n=5:5)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D) Representative images of club cell organoid cultures (stromal-free system) from wide-type mice or Gdpd2 KO (X</a:t>
            </a:r>
            <a:r>
              <a:rPr lang="en-US" altLang="zh-CN" sz="1100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O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Y) mice (n=5:5), at day 8 after plating. Scale bar: 500 </a:t>
            </a:r>
            <a:r>
              <a:rPr lang="en-US" altLang="zh-CN" sz="11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(E, F) Diameter and CFEs of club cell colonies under the conditions described in (C) (n=5:5).</a:t>
            </a:r>
            <a:r>
              <a:rPr lang="en-US" altLang="zh-CN" sz="1100" kern="1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1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sults are represented by mean ± SD, *p &lt; 0.05, ***p &lt; 0.001, ****p &lt; 0.0001; as determined by Student’s t-test.</a:t>
            </a:r>
            <a:endParaRPr lang="zh-CN" altLang="zh-CN" sz="1100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773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b="1" dirty="0">
            <a:solidFill>
              <a:srgbClr val="00B050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686</TotalTime>
  <Words>222</Words>
  <Application>Microsoft Office PowerPoint</Application>
  <PresentationFormat>自定义</PresentationFormat>
  <Paragraphs>2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vel</dc:creator>
  <cp:lastModifiedBy>岳青</cp:lastModifiedBy>
  <cp:revision>1575</cp:revision>
  <cp:lastPrinted>2020-08-07T09:00:00Z</cp:lastPrinted>
  <dcterms:created xsi:type="dcterms:W3CDTF">2019-12-31T01:32:00Z</dcterms:created>
  <dcterms:modified xsi:type="dcterms:W3CDTF">2023-04-16T02:41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700</vt:lpwstr>
  </property>
  <property fmtid="{D5CDD505-2E9C-101B-9397-08002B2CF9AE}" pid="3" name="ICV">
    <vt:lpwstr>F6B2A8FAB1314C0CA40D9C07A9579253</vt:lpwstr>
  </property>
</Properties>
</file>